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-2256" y="-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C219-B558-4972-B9ED-CCC1A7BA3F75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37951-2DDA-4356-B5DE-5DE173B1A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537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C219-B558-4972-B9ED-CCC1A7BA3F75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37951-2DDA-4356-B5DE-5DE173B1A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307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C219-B558-4972-B9ED-CCC1A7BA3F75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37951-2DDA-4356-B5DE-5DE173B1A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497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C219-B558-4972-B9ED-CCC1A7BA3F75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37951-2DDA-4356-B5DE-5DE173B1A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40344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C219-B558-4972-B9ED-CCC1A7BA3F75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37951-2DDA-4356-B5DE-5DE173B1A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448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C219-B558-4972-B9ED-CCC1A7BA3F75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37951-2DDA-4356-B5DE-5DE173B1A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111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C219-B558-4972-B9ED-CCC1A7BA3F75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37951-2DDA-4356-B5DE-5DE173B1A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643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C219-B558-4972-B9ED-CCC1A7BA3F75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37951-2DDA-4356-B5DE-5DE173B1A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522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C219-B558-4972-B9ED-CCC1A7BA3F75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37951-2DDA-4356-B5DE-5DE173B1A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952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C219-B558-4972-B9ED-CCC1A7BA3F75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37951-2DDA-4356-B5DE-5DE173B1A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081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C219-B558-4972-B9ED-CCC1A7BA3F75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37951-2DDA-4356-B5DE-5DE173B1A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782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3EC219-B558-4972-B9ED-CCC1A7BA3F75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637951-2DDA-4356-B5DE-5DE173B1A9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4550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1" y="8576846"/>
            <a:ext cx="6324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/>
              <a:t>Table </a:t>
            </a:r>
            <a:r>
              <a:rPr lang="en-US" sz="1600" b="1" i="1" dirty="0"/>
              <a:t>S1. HCC patient demographics.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0810770"/>
              </p:ext>
            </p:extLst>
          </p:nvPr>
        </p:nvGraphicFramePr>
        <p:xfrm>
          <a:off x="405716" y="3276600"/>
          <a:ext cx="6172199" cy="195008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01585"/>
                <a:gridCol w="961901"/>
                <a:gridCol w="721426"/>
                <a:gridCol w="679465"/>
                <a:gridCol w="1002607"/>
                <a:gridCol w="882998"/>
                <a:gridCol w="1122217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ient</a:t>
                      </a:r>
                      <a:endParaRPr 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FP (ng/ml)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x</a:t>
                      </a:r>
                      <a:endParaRPr lang="en-US" sz="15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ce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ge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sk Factor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ucasian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CV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40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ian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BV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00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spanic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a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00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ian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b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CV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0421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6</Words>
  <Application>Microsoft Office PowerPoint</Application>
  <PresentationFormat>On-screen Show (4:3)</PresentationFormat>
  <Paragraphs>3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P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sa H. Butterfield</dc:creator>
  <cp:lastModifiedBy>Lisa H. Butterfield</cp:lastModifiedBy>
  <cp:revision>1</cp:revision>
  <dcterms:created xsi:type="dcterms:W3CDTF">2015-03-17T15:42:07Z</dcterms:created>
  <dcterms:modified xsi:type="dcterms:W3CDTF">2015-03-17T15:47:49Z</dcterms:modified>
</cp:coreProperties>
</file>